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32"/>
  </p:notesMasterIdLst>
  <p:sldIdLst>
    <p:sldId id="258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72" r:id="rId14"/>
    <p:sldId id="273" r:id="rId15"/>
    <p:sldId id="274" r:id="rId16"/>
    <p:sldId id="275" r:id="rId17"/>
    <p:sldId id="276" r:id="rId18"/>
    <p:sldId id="277" r:id="rId19"/>
    <p:sldId id="278" r:id="rId20"/>
    <p:sldId id="279" r:id="rId21"/>
    <p:sldId id="280" r:id="rId22"/>
    <p:sldId id="281" r:id="rId23"/>
    <p:sldId id="282" r:id="rId24"/>
    <p:sldId id="283" r:id="rId25"/>
    <p:sldId id="284" r:id="rId26"/>
    <p:sldId id="285" r:id="rId27"/>
    <p:sldId id="286" r:id="rId28"/>
    <p:sldId id="287" r:id="rId29"/>
    <p:sldId id="288" r:id="rId30"/>
    <p:sldId id="289" r:id="rId31"/>
  </p:sldIdLst>
  <p:sldSz cx="9144000" cy="6858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66"/>
    <a:srgbClr val="000099"/>
    <a:srgbClr val="FFFF00"/>
    <a:srgbClr val="0000CC"/>
    <a:srgbClr val="33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0816" autoAdjust="0"/>
  </p:normalViewPr>
  <p:slideViewPr>
    <p:cSldViewPr>
      <p:cViewPr varScale="1">
        <p:scale>
          <a:sx n="59" d="100"/>
          <a:sy n="59" d="100"/>
        </p:scale>
        <p:origin x="-281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notesMaster" Target="notesMasters/notesMaster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printerSettings" Target="printerSettings/printerSettings1.bin"/><Relationship Id="rId34" Type="http://schemas.openxmlformats.org/officeDocument/2006/relationships/presProps" Target="presProps.xml"/><Relationship Id="rId35" Type="http://schemas.openxmlformats.org/officeDocument/2006/relationships/viewProps" Target="viewProps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198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17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4198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4199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199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DA286D6-C0F8-4088-BE11-C84F8F1A7C3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486055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1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7.xml"/></Relationships>
</file>

<file path=ppt/notesSlides/_rels/notesSlide1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8.xml"/></Relationships>
</file>

<file path=ppt/notesSlides/_rels/notesSlide1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9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_rels/notesSlide2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1.xml"/></Relationships>
</file>

<file path=ppt/notesSlides/_rels/notesSlide2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2.xml"/></Relationships>
</file>

<file path=ppt/notesSlides/_rels/notesSlide2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3.xml"/></Relationships>
</file>

<file path=ppt/notesSlides/_rels/notesSlide2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4.xml"/></Relationships>
</file>

<file path=ppt/notesSlides/_rels/notesSlide2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5.xml"/></Relationships>
</file>

<file path=ppt/notesSlides/_rels/notesSlide2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6.xml"/></Relationships>
</file>

<file path=ppt/notesSlides/_rels/notesSlide2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7.xml"/></Relationships>
</file>

<file path=ppt/notesSlides/_rels/notesSlide2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8.xml"/></Relationships>
</file>

<file path=ppt/notesSlides/_rels/notesSlide2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9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0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fld id="{45F66FFA-2014-4733-8925-FCFC5BBAC6F5}" type="slidenum">
              <a:rPr lang="en-US" smtClean="0"/>
              <a:pPr/>
              <a:t>1</a:t>
            </a:fld>
            <a:endParaRPr lang="en-US" dirty="0" smtClean="0"/>
          </a:p>
        </p:txBody>
      </p:sp>
      <p:sp>
        <p:nvSpPr>
          <p:cNvPr id="819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196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noFill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F6EDF21B-AC12-8044-A6F6-4A6851A76660}" type="slidenum">
              <a:rPr lang="en-US"/>
              <a:pPr/>
              <a:t>10</a:t>
            </a:fld>
            <a:endParaRPr lang="en-US" dirty="0"/>
          </a:p>
        </p:txBody>
      </p:sp>
      <p:sp>
        <p:nvSpPr>
          <p:cNvPr id="4096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096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the students list pertinent items of the physical exam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Give students 1-2 minutes to generate answer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Answers can be recorded on a whiteboard, easel or other shared medium.</a:t>
            </a:r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0D19D4CC-3E27-CD49-820D-033A327690B3}" type="slidenum">
              <a:rPr lang="en-US"/>
              <a:pPr/>
              <a:t>11</a:t>
            </a:fld>
            <a:endParaRPr lang="en-US" dirty="0"/>
          </a:p>
        </p:txBody>
      </p:sp>
      <p:sp>
        <p:nvSpPr>
          <p:cNvPr id="4198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198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the steps of evaluation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review the correct physical exam format.</a:t>
            </a:r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6445CC5-3DA2-8042-9154-BE6FAEADCD4A}" type="slidenum">
              <a:rPr lang="en-US"/>
              <a:pPr/>
              <a:t>12</a:t>
            </a:fld>
            <a:endParaRPr lang="en-US" dirty="0"/>
          </a:p>
        </p:txBody>
      </p:sp>
      <p:sp>
        <p:nvSpPr>
          <p:cNvPr id="4300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301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the findings on physical exam for the patient in the case. The findings are intended to allow students to eliminate most of the possible diagnose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review the correct physical exam forma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Review the physical findings with the students.</a:t>
            </a:r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AE1E216D-1B1F-9941-A6CA-EEA3CE96B83B}" type="slidenum">
              <a:rPr lang="en-US"/>
              <a:pPr/>
              <a:t>13</a:t>
            </a:fld>
            <a:endParaRPr lang="en-US" dirty="0"/>
          </a:p>
        </p:txBody>
      </p:sp>
      <p:sp>
        <p:nvSpPr>
          <p:cNvPr id="4403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403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the finding on pelvic exam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review the correct pelvic exam forma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Review the findings with the students.</a:t>
            </a:r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B74F4226-32C6-ED42-A304-B50027BDCA42}" type="slidenum">
              <a:rPr lang="en-US"/>
              <a:pPr/>
              <a:t>14</a:t>
            </a:fld>
            <a:endParaRPr lang="en-US" dirty="0"/>
          </a:p>
        </p:txBody>
      </p:sp>
      <p:sp>
        <p:nvSpPr>
          <p:cNvPr id="4505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505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students suggest laboratory tests for this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Give students 1-2 minutes to generate answer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Answers can be recorded on a whiteboard, easel or other shared medium.</a:t>
            </a:r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2E3638A1-4C35-7E44-B220-E128D8525D90}" type="slidenum">
              <a:rPr lang="en-US"/>
              <a:pPr/>
              <a:t>15</a:t>
            </a:fld>
            <a:endParaRPr lang="en-US" dirty="0"/>
          </a:p>
        </p:txBody>
      </p:sp>
      <p:sp>
        <p:nvSpPr>
          <p:cNvPr id="4608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608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some possible choices for laboratory test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review the appropriate laboratory tests for this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Point out which tests are essential, which are non-essential, which are inappropriate, and relative cost of tests (if known).</a:t>
            </a:r>
          </a:p>
          <a:p>
            <a:pPr>
              <a:spcBef>
                <a:spcPts val="404"/>
              </a:spcBef>
            </a:pPr>
            <a:endParaRPr lang="en-US" dirty="0">
              <a:cs typeface="Arial Unicode MS" charset="0"/>
            </a:endParaRPr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6D078047-B3D3-EB4F-B1DE-EA3758DD9A10}" type="slidenum">
              <a:rPr lang="en-US"/>
              <a:pPr/>
              <a:t>16</a:t>
            </a:fld>
            <a:endParaRPr lang="en-US" dirty="0"/>
          </a:p>
        </p:txBody>
      </p:sp>
      <p:sp>
        <p:nvSpPr>
          <p:cNvPr id="4710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710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the laboratory findings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discuss the relative costs, benefits and utility of different laboratory test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Review the results with the students.</a:t>
            </a:r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06BDBF09-F620-9F46-8680-FBE2C30F7A4D}" type="slidenum">
              <a:rPr lang="en-US"/>
              <a:pPr/>
              <a:t>17</a:t>
            </a:fld>
            <a:endParaRPr lang="en-US" dirty="0"/>
          </a:p>
        </p:txBody>
      </p:sp>
      <p:sp>
        <p:nvSpPr>
          <p:cNvPr id="4812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813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the laboratory findings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discuss the relative costs, benefits and utility of different laboratory tests. For example, is a B-HCG level needed?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Review the results with the students.</a:t>
            </a:r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DF649356-8389-D341-9034-DBFC08E4AE3D}" type="slidenum">
              <a:rPr lang="en-US"/>
              <a:pPr/>
              <a:t>18</a:t>
            </a:fld>
            <a:endParaRPr lang="en-US" dirty="0"/>
          </a:p>
        </p:txBody>
      </p:sp>
      <p:sp>
        <p:nvSpPr>
          <p:cNvPr id="4915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915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students suggest imaging studies for this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Give students 1-2 minutes to generate answer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Answers can be recorded on a whiteboard, easel or other shared medium.</a:t>
            </a:r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6537E59-11F7-5F4E-827D-48BCDBA14FFE}" type="slidenum">
              <a:rPr lang="en-US"/>
              <a:pPr/>
              <a:t>19</a:t>
            </a:fld>
            <a:endParaRPr lang="en-US" dirty="0"/>
          </a:p>
        </p:txBody>
      </p:sp>
      <p:sp>
        <p:nvSpPr>
          <p:cNvPr id="5017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017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some possible choices for  imaging studies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review the appropriate imaging studies for this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Point out which tests are essential, which are non-essential, which are inappropriate, and relative cost of tests (if known).</a:t>
            </a: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D7200DB-37B7-D644-AFAB-C9B164FE43F3}" type="slidenum">
              <a:rPr lang="en-US"/>
              <a:pPr/>
              <a:t>2</a:t>
            </a:fld>
            <a:endParaRPr lang="en-US" dirty="0"/>
          </a:p>
        </p:txBody>
      </p:sp>
      <p:sp>
        <p:nvSpPr>
          <p:cNvPr id="3276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210236" y="694171"/>
            <a:ext cx="4437529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277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227BB343-A07C-DE41-BA4C-293CA497B86F}" type="slidenum">
              <a:rPr lang="en-US"/>
              <a:pPr/>
              <a:t>20</a:t>
            </a:fld>
            <a:endParaRPr lang="en-US" dirty="0"/>
          </a:p>
        </p:txBody>
      </p:sp>
      <p:sp>
        <p:nvSpPr>
          <p:cNvPr id="5120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120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some possible choices for  imaging studies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review the appropriate imaging studies for this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Point out which tests are essential, which are non-essential, which are inappropriate, and relative cost of tests (if known).</a:t>
            </a:r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4B0A6170-A643-494B-B24B-D33F3F53E42C}" type="slidenum">
              <a:rPr lang="en-US"/>
              <a:pPr/>
              <a:t>21</a:t>
            </a:fld>
            <a:endParaRPr lang="en-US" dirty="0"/>
          </a:p>
        </p:txBody>
      </p:sp>
      <p:sp>
        <p:nvSpPr>
          <p:cNvPr id="5222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222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students suggest treatment options for this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Give students 1-2 minutes to generate answer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Answers can be recorded on a whiteboard, easel or other shared medium.</a:t>
            </a:r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214E1434-0DC5-D34E-B69C-8CF12D00E4F3}" type="slidenum">
              <a:rPr lang="en-US"/>
              <a:pPr/>
              <a:t>22</a:t>
            </a:fld>
            <a:endParaRPr lang="en-US" dirty="0"/>
          </a:p>
        </p:txBody>
      </p:sp>
      <p:sp>
        <p:nvSpPr>
          <p:cNvPr id="5324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325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the three management options. The following slides go into more detail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e discussion is likely to become more of a lecture at this point with third year medical students, as few of them will be </a:t>
            </a:r>
            <a:r>
              <a:rPr lang="en-US" dirty="0" smtClean="0">
                <a:cs typeface="Arial Unicode MS" charset="0"/>
              </a:rPr>
              <a:t>knowledgeable </a:t>
            </a:r>
            <a:r>
              <a:rPr lang="en-US" dirty="0">
                <a:cs typeface="Arial Unicode MS" charset="0"/>
              </a:rPr>
              <a:t>about the details of treatment option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e discussion can become more detailed for more advanced learners.</a:t>
            </a:r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D0FD0132-09DF-0A40-B33F-087F6875DE96}" type="slidenum">
              <a:rPr lang="en-US"/>
              <a:pPr/>
              <a:t>23</a:t>
            </a:fld>
            <a:endParaRPr lang="en-US" dirty="0"/>
          </a:p>
        </p:txBody>
      </p:sp>
      <p:sp>
        <p:nvSpPr>
          <p:cNvPr id="5427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427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gives basic information on expectant management of spontaneous abortion.</a:t>
            </a:r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53117AC3-1EB6-CE4D-85C9-3F9AB89B7A32}" type="slidenum">
              <a:rPr lang="en-US"/>
              <a:pPr/>
              <a:t>24</a:t>
            </a:fld>
            <a:endParaRPr lang="en-US" dirty="0"/>
          </a:p>
        </p:txBody>
      </p:sp>
      <p:sp>
        <p:nvSpPr>
          <p:cNvPr id="5529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529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gives basic information on medical management of spontaneous abortion.</a:t>
            </a:r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44406B06-5BAC-E64C-A815-C4F5D28C2E94}" type="slidenum">
              <a:rPr lang="en-US"/>
              <a:pPr/>
              <a:t>25</a:t>
            </a:fld>
            <a:endParaRPr lang="en-US" dirty="0"/>
          </a:p>
        </p:txBody>
      </p:sp>
      <p:sp>
        <p:nvSpPr>
          <p:cNvPr id="5632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632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gives basic information on medical management of spontaneous abortion.</a:t>
            </a:r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1B53D014-C88C-9943-956C-DFCBCA731E7B}" type="slidenum">
              <a:rPr lang="en-US"/>
              <a:pPr/>
              <a:t>26</a:t>
            </a:fld>
            <a:endParaRPr lang="en-US" dirty="0"/>
          </a:p>
        </p:txBody>
      </p:sp>
      <p:sp>
        <p:nvSpPr>
          <p:cNvPr id="5734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734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gives basic information on surgical management of spontaneous abortion.</a:t>
            </a:r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E70B588C-0414-8141-9798-86DA888EBB42}" type="slidenum">
              <a:rPr lang="en-US"/>
              <a:pPr/>
              <a:t>27</a:t>
            </a:fld>
            <a:endParaRPr lang="en-US" dirty="0"/>
          </a:p>
        </p:txBody>
      </p:sp>
      <p:sp>
        <p:nvSpPr>
          <p:cNvPr id="5836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837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emphasizes the need for surgical management if a patient is </a:t>
            </a:r>
            <a:r>
              <a:rPr lang="en-US" dirty="0" smtClean="0">
                <a:cs typeface="Arial Unicode MS" charset="0"/>
              </a:rPr>
              <a:t>hemodynamically </a:t>
            </a:r>
            <a:r>
              <a:rPr lang="en-US" dirty="0">
                <a:cs typeface="Arial Unicode MS" charset="0"/>
              </a:rPr>
              <a:t>unstable or has a uterine infection.</a:t>
            </a:r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C08C8DFA-2D58-2243-B2B9-E5456DB077CA}" type="slidenum">
              <a:rPr lang="en-US"/>
              <a:pPr/>
              <a:t>28</a:t>
            </a:fld>
            <a:endParaRPr lang="en-US" dirty="0"/>
          </a:p>
        </p:txBody>
      </p:sp>
      <p:sp>
        <p:nvSpPr>
          <p:cNvPr id="5939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5939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students answer question prompt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Give students 1-2 minutes to generate answer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 Answers can be recorded on a whiteboard, easel or other shared medium.</a:t>
            </a:r>
          </a:p>
          <a:p>
            <a:pPr>
              <a:spcBef>
                <a:spcPts val="404"/>
              </a:spcBef>
            </a:pPr>
            <a:endParaRPr lang="en-US" dirty="0">
              <a:cs typeface="Arial Unicode MS" charset="0"/>
            </a:endParaRPr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FD8A6420-9B87-CD4E-A439-ABF31CB4D623}" type="slidenum">
              <a:rPr lang="en-US"/>
              <a:pPr/>
              <a:t>29</a:t>
            </a:fld>
            <a:endParaRPr lang="en-US" dirty="0"/>
          </a:p>
        </p:txBody>
      </p:sp>
      <p:sp>
        <p:nvSpPr>
          <p:cNvPr id="6041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041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summarizes pre-operative care and can be used to generate discussion of obtaining informed consent, communication with patients' families</a:t>
            </a:r>
          </a:p>
          <a:p>
            <a:pPr>
              <a:spcBef>
                <a:spcPts val="404"/>
              </a:spcBef>
            </a:pPr>
            <a:endParaRPr lang="en-US" dirty="0">
              <a:cs typeface="Arial Unicode MS" charset="0"/>
            </a:endParaRPr>
          </a:p>
          <a:p>
            <a:pPr>
              <a:spcBef>
                <a:spcPts val="404"/>
              </a:spcBef>
            </a:pPr>
            <a:endParaRPr lang="en-US" dirty="0">
              <a:cs typeface="Arial Unicode MS" charset="0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2FB934D-9D72-BD4B-8965-3B852C0D7636}" type="slidenum">
              <a:rPr lang="en-US"/>
              <a:pPr/>
              <a:t>3</a:t>
            </a:fld>
            <a:endParaRPr lang="en-US" dirty="0"/>
          </a:p>
        </p:txBody>
      </p:sp>
      <p:sp>
        <p:nvSpPr>
          <p:cNvPr id="3379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379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is a review of all the different types of abortions.</a:t>
            </a:r>
          </a:p>
        </p:txBody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DCA60240-D8F1-D541-8A6F-334542E1654F}" type="slidenum">
              <a:rPr lang="en-US"/>
              <a:pPr/>
              <a:t>30</a:t>
            </a:fld>
            <a:endParaRPr lang="en-US" dirty="0"/>
          </a:p>
        </p:txBody>
      </p:sp>
      <p:sp>
        <p:nvSpPr>
          <p:cNvPr id="6144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6144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summarizes post-operative care and can be used to generate discussion of possible postoperative complications, as well as contraception and preconception counseling.</a:t>
            </a:r>
          </a:p>
          <a:p>
            <a:pPr>
              <a:spcBef>
                <a:spcPts val="404"/>
              </a:spcBef>
            </a:pPr>
            <a:endParaRPr lang="en-US" dirty="0">
              <a:cs typeface="Arial Unicode MS" charset="0"/>
            </a:endParaRPr>
          </a:p>
          <a:p>
            <a:pPr>
              <a:spcBef>
                <a:spcPts val="404"/>
              </a:spcBef>
            </a:pPr>
            <a:endParaRPr lang="en-US" dirty="0">
              <a:cs typeface="Arial Unicode MS" charset="0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0F1AD645-CC4A-964D-ACCA-01CB08CF7E33}" type="slidenum">
              <a:rPr lang="en-US"/>
              <a:pPr/>
              <a:t>4</a:t>
            </a:fld>
            <a:endParaRPr lang="en-US" dirty="0"/>
          </a:p>
        </p:txBody>
      </p:sp>
      <p:sp>
        <p:nvSpPr>
          <p:cNvPr id="3481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481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students suggest differential diagnoses of  first trimester bleeding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Give students 1-2 minutes to generate answer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 Answers can be recorded on a whiteboard, easel or other shared medium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e following slide provides a comprehensive differential diagnosis.</a:t>
            </a: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ED75D5DB-E655-474A-8DFE-635FBF0D76AB}" type="slidenum">
              <a:rPr lang="en-US"/>
              <a:pPr/>
              <a:t>5</a:t>
            </a:fld>
            <a:endParaRPr lang="en-US" dirty="0"/>
          </a:p>
        </p:txBody>
      </p:sp>
      <p:sp>
        <p:nvSpPr>
          <p:cNvPr id="35841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5842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Instructor can review this list and compare to that generated by student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Discuss </a:t>
            </a:r>
            <a:r>
              <a:rPr lang="en-US" dirty="0" smtClean="0">
                <a:cs typeface="Arial Unicode MS" charset="0"/>
              </a:rPr>
              <a:t>subtleties </a:t>
            </a:r>
            <a:r>
              <a:rPr lang="en-US" dirty="0">
                <a:cs typeface="Arial Unicode MS" charset="0"/>
              </a:rPr>
              <a:t>of presentations of different etiologies.</a:t>
            </a: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83823D94-0CBE-984A-8CFB-F995F20FC0C2}" type="slidenum">
              <a:rPr lang="en-US"/>
              <a:pPr/>
              <a:t>6</a:t>
            </a:fld>
            <a:endParaRPr lang="en-US" dirty="0"/>
          </a:p>
        </p:txBody>
      </p:sp>
      <p:sp>
        <p:nvSpPr>
          <p:cNvPr id="36865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6866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students  offer steps in evaluation of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hould take 1-2 minute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Steps in the evaluation can be recorded on whiteboard, easel or other shared medium.</a:t>
            </a: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7B8185A3-B921-E24E-8CD5-283013349F38}" type="slidenum">
              <a:rPr lang="en-US"/>
              <a:pPr/>
              <a:t>7</a:t>
            </a:fld>
            <a:endParaRPr lang="en-US" dirty="0"/>
          </a:p>
        </p:txBody>
      </p:sp>
      <p:sp>
        <p:nvSpPr>
          <p:cNvPr id="37889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4588" y="693738"/>
            <a:ext cx="4567237" cy="3427412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7890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1" y="4342535"/>
            <a:ext cx="5485279" cy="4113068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projected while students suggest  items to ask on the history for this patient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Give students 1-2 minutes to generate answers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 Answers can be recorded on a whiteboard, easel or other shared medium.</a:t>
            </a:r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33612A08-F3B9-A749-84AF-7B533EB085E5}" type="slidenum">
              <a:rPr lang="en-US"/>
              <a:pPr/>
              <a:t>8</a:t>
            </a:fld>
            <a:endParaRPr lang="en-US" dirty="0"/>
          </a:p>
        </p:txBody>
      </p:sp>
      <p:sp>
        <p:nvSpPr>
          <p:cNvPr id="38913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8914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lists the items in the history for the patient in the case.</a:t>
            </a:r>
          </a:p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This slide can be used to review the correct history format.</a:t>
            </a:r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E242390F-CE77-3B4E-8381-418A4BC5E1E4}" type="slidenum">
              <a:rPr lang="en-US"/>
              <a:pPr/>
              <a:t>9</a:t>
            </a:fld>
            <a:endParaRPr lang="en-US" dirty="0"/>
          </a:p>
        </p:txBody>
      </p:sp>
      <p:sp>
        <p:nvSpPr>
          <p:cNvPr id="3993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1143000" y="693738"/>
            <a:ext cx="457200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3993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 sz="1200">
                <a:solidFill>
                  <a:srgbClr val="000000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spcBef>
                <a:spcPts val="404"/>
              </a:spcBef>
            </a:pPr>
            <a:r>
              <a:rPr lang="en-US" dirty="0">
                <a:cs typeface="Arial Unicode MS" charset="0"/>
              </a:rPr>
              <a:t>Review the case history with the students. The case is intended to suggest many possible causes for bleeding, including some unlikely possibilities, to help generate a wide differential diagnosis.</a:t>
            </a: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3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7"/>
          <p:cNvSpPr>
            <a:spLocks noChangeArrowheads="1"/>
          </p:cNvSpPr>
          <p:nvPr userDrawn="1"/>
        </p:nvSpPr>
        <p:spPr bwMode="auto">
          <a:xfrm>
            <a:off x="0" y="2189163"/>
            <a:ext cx="9144000" cy="4668837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 dirty="0"/>
          </a:p>
        </p:txBody>
      </p:sp>
      <p:pic>
        <p:nvPicPr>
          <p:cNvPr id="4" name="Picture 4" descr="BIDMC_Harvard_lockup"/>
          <p:cNvPicPr>
            <a:picLocks noChangeAspect="1" noChangeArrowheads="1"/>
          </p:cNvPicPr>
          <p:nvPr userDrawn="1"/>
        </p:nvPicPr>
        <p:blipFill>
          <a:blip r:embed="rId2" cstate="print">
            <a:lum bright="4000" contrast="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275" y="946150"/>
            <a:ext cx="6161088" cy="908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083" name="Rectangle 3"/>
          <p:cNvSpPr>
            <a:spLocks noGrp="1" noChangeArrowheads="1"/>
          </p:cNvSpPr>
          <p:nvPr>
            <p:ph type="ctrTitle"/>
          </p:nvPr>
        </p:nvSpPr>
        <p:spPr>
          <a:xfrm>
            <a:off x="2936875" y="3419475"/>
            <a:ext cx="5162550" cy="2027238"/>
          </a:xfrm>
        </p:spPr>
        <p:txBody>
          <a:bodyPr anchor="t"/>
          <a:lstStyle>
            <a:lvl1pPr>
              <a:defRPr sz="180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noProof="0" smtClean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494319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0C09A9-E3EF-4C70-9510-50725F1306F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5745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57938" y="530225"/>
            <a:ext cx="1658937" cy="472916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9538" y="530225"/>
            <a:ext cx="4826000" cy="472916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A1270E-0CFA-420A-B7C8-1D9A37316B64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678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629F02-CDA1-4636-BA55-4830E6F1E6D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1565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7FE25E-33CB-4CF6-858B-69DC75BB4A6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3284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79538" y="1354138"/>
            <a:ext cx="3241675" cy="39052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73613" y="1354138"/>
            <a:ext cx="3243262" cy="39052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D85467-69C7-4D04-AE9A-2C99BCC87574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334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96EDAD1-77E4-45A2-9257-6286E0FC4584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8443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BD15C6-451A-43CC-9232-821AF423DD7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6868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5EDEBB7-D689-4AC6-B210-53C284EA154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8051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3DAE7E-404A-45CD-8B5B-7893D3D24ED1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0980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dirty="0" smtClean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9021F44-D45D-4EDF-B89C-D2D9FD4F1514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2044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3" Type="http://schemas.openxmlformats.org/officeDocument/2006/relationships/image" Target="../media/image1.png"/><Relationship Id="rId1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595438" y="530225"/>
            <a:ext cx="6421437" cy="688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79538" y="1354138"/>
            <a:ext cx="6637337" cy="390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5060" name="Rectangle 4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+mn-lt"/>
                <a:ea typeface="+mn-ea"/>
              </a:defRPr>
            </a:lvl1pPr>
          </a:lstStyle>
          <a:p>
            <a:pPr>
              <a:defRPr/>
            </a:pPr>
            <a:fld id="{65B7D64C-8BC3-4E58-A634-7EFCC8719B4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pic>
        <p:nvPicPr>
          <p:cNvPr id="2053" name="Picture 5" descr="HMSshield 200_cmyk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9463" y="7989888"/>
            <a:ext cx="2571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 descr="BIDMC_Harvard_lockup"/>
          <p:cNvPicPr>
            <a:picLocks noChangeAspect="1" noChangeArrowheads="1"/>
          </p:cNvPicPr>
          <p:nvPr/>
        </p:nvPicPr>
        <p:blipFill>
          <a:blip r:embed="rId14" cstate="print">
            <a:lum bright="4000" contrast="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275" y="6126163"/>
            <a:ext cx="3505200" cy="51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5" name="Line 7"/>
          <p:cNvSpPr>
            <a:spLocks noChangeShapeType="1"/>
          </p:cNvSpPr>
          <p:nvPr/>
        </p:nvSpPr>
        <p:spPr bwMode="auto">
          <a:xfrm>
            <a:off x="0" y="5991225"/>
            <a:ext cx="9144000" cy="0"/>
          </a:xfrm>
          <a:prstGeom prst="line">
            <a:avLst/>
          </a:prstGeom>
          <a:noFill/>
          <a:ln w="9525">
            <a:solidFill>
              <a:schemeClr val="tx2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43" r:id="rId1"/>
    <p:sldLayoutId id="2147483732" r:id="rId2"/>
    <p:sldLayoutId id="2147483733" r:id="rId3"/>
    <p:sldLayoutId id="2147483734" r:id="rId4"/>
    <p:sldLayoutId id="2147483735" r:id="rId5"/>
    <p:sldLayoutId id="2147483736" r:id="rId6"/>
    <p:sldLayoutId id="2147483737" r:id="rId7"/>
    <p:sldLayoutId id="2147483738" r:id="rId8"/>
    <p:sldLayoutId id="2147483739" r:id="rId9"/>
    <p:sldLayoutId id="2147483740" r:id="rId10"/>
    <p:sldLayoutId id="2147483741" r:id="rId11"/>
  </p:sldLayoutIdLst>
  <p:txStyles>
    <p:titleStyle>
      <a:lvl1pPr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tx2"/>
          </a:solidFill>
          <a:latin typeface="Albany AMT" pitchFamily="34" charset="0"/>
          <a:ea typeface="ＭＳ Ｐゴシック" pitchFamily="34" charset="-128"/>
        </a:defRPr>
      </a:lvl9pPr>
    </p:titleStyle>
    <p:bodyStyle>
      <a:lvl1pPr marL="228600" indent="-228600" algn="l" rtl="0" eaLnBrk="1" fontAlgn="base" hangingPunct="1">
        <a:spcBef>
          <a:spcPct val="20000"/>
        </a:spcBef>
        <a:spcAft>
          <a:spcPct val="0"/>
        </a:spcAft>
        <a:buClr>
          <a:schemeClr val="tx2"/>
        </a:buClr>
        <a:buFont typeface="Times" pitchFamily="18" charset="0"/>
        <a:buChar char="•"/>
        <a:defRPr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lr>
          <a:srgbClr val="0D1D6A"/>
        </a:buClr>
        <a:buFont typeface="Times" pitchFamily="18" charset="0"/>
        <a:buChar char="•"/>
        <a:defRPr sz="16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har char="–"/>
        <a:defRPr sz="12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har char="»"/>
        <a:defRPr sz="1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1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1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1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1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3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5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6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8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9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0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3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4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5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6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7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8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9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0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09600" y="3419475"/>
            <a:ext cx="7497763" cy="2027238"/>
          </a:xfrm>
        </p:spPr>
        <p:txBody>
          <a:bodyPr/>
          <a:lstStyle/>
          <a:p>
            <a:r>
              <a:rPr lang="en-US" sz="3200" dirty="0">
                <a:latin typeface="Calibri" pitchFamily="34" charset="0"/>
              </a:rPr>
              <a:t>An Approach to Diagnosis and Management of  First Trimester Bleeding </a:t>
            </a:r>
            <a:br>
              <a:rPr lang="en-US" sz="3200" dirty="0">
                <a:latin typeface="Calibri" pitchFamily="34" charset="0"/>
              </a:rPr>
            </a:br>
            <a:endParaRPr lang="en-US" sz="3200" dirty="0" smtClean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1266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Physical Exam</a:t>
            </a:r>
          </a:p>
          <a:p>
            <a:pPr marL="78193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dirty="0"/>
          </a:p>
          <a:p>
            <a:pPr marL="78193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89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2290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Physical Exam</a:t>
            </a:r>
          </a:p>
          <a:p>
            <a:pPr marL="1344980" lvl="1" indent="-514088">
              <a:buClrTx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Vital signs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Head and Neck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Cardiovascular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Abdomen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Extremities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Pelvic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Rectangle 2"/>
          <p:cNvSpPr>
            <a:spLocks noGrp="1" noChangeArrowheads="1"/>
          </p:cNvSpPr>
          <p:nvPr>
            <p:ph type="body" idx="4294967295"/>
          </p:nvPr>
        </p:nvSpPr>
        <p:spPr>
          <a:xfrm>
            <a:off x="0" y="228600"/>
            <a:ext cx="8228013" cy="5995988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Physical Exam</a:t>
            </a:r>
          </a:p>
          <a:p>
            <a:pPr marL="1344980" lvl="1" indent="-514088">
              <a:buClrTx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Vital Signs T 37, BP 110/72, HR 80, RR 14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Head and Neck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Mucosa moist, pink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Oropharynx clear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Normal dentition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No </a:t>
            </a:r>
            <a:r>
              <a:rPr lang="en-US" sz="2000" dirty="0"/>
              <a:t>thyromegaly</a:t>
            </a:r>
            <a:endParaRPr lang="en-US" sz="2000" dirty="0"/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Cardiovascular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Regular rate and rhythm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Lung fields clear to auscultation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Abdomen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Soft, mildly tender to deep palpation over the </a:t>
            </a:r>
            <a:r>
              <a:rPr lang="en-US" sz="2000" dirty="0" smtClean="0"/>
              <a:t>Supra-pubic </a:t>
            </a:r>
            <a:r>
              <a:rPr lang="en-US" sz="2000" dirty="0"/>
              <a:t>region, no CVAT, masses, guarding, rebound or </a:t>
            </a:r>
            <a:r>
              <a:rPr lang="en-US" sz="2000" dirty="0" smtClean="0"/>
              <a:t>organomegaly</a:t>
            </a:r>
            <a:endParaRPr lang="en-US" sz="2000" dirty="0"/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Extremities</a:t>
            </a:r>
          </a:p>
          <a:p>
            <a:pPr marL="2073631" lvl="2" indent="-413287">
              <a:buFont typeface="Times New Roman" charset="0"/>
              <a:buChar char="•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000" dirty="0"/>
              <a:t>No edema or varicosities</a:t>
            </a:r>
          </a:p>
          <a:p>
            <a:pPr marL="1344980" lvl="1" indent="-514088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sz="2000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Rectangle 1"/>
          <p:cNvSpPr>
            <a:spLocks noGrp="1" noChangeArrowheads="1"/>
          </p:cNvSpPr>
          <p:nvPr>
            <p:ph type="title"/>
          </p:nvPr>
        </p:nvSpPr>
        <p:spPr>
          <a:xfrm>
            <a:off x="1704" y="-304800"/>
            <a:ext cx="8684641" cy="143007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4338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152400" y="1219200"/>
            <a:ext cx="8228160" cy="4526395"/>
          </a:xfrm>
          <a:ln/>
        </p:spPr>
        <p:txBody>
          <a:bodyPr>
            <a:normAutofit lnSpcReduction="10000"/>
          </a:bodyPr>
          <a:lstStyle/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Pelvic Exam</a:t>
            </a:r>
          </a:p>
          <a:p>
            <a:pPr lvl="1" indent="-254884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Normal female external genitalia, no lesions </a:t>
            </a:r>
            <a:r>
              <a:rPr lang="en-US" sz="2800" dirty="0" smtClean="0"/>
              <a:t>or trauma</a:t>
            </a:r>
            <a:r>
              <a:rPr lang="en-US" sz="2800" dirty="0"/>
              <a:t>.</a:t>
            </a:r>
          </a:p>
          <a:p>
            <a:pPr lvl="1" indent="-254884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Vagina with small amount of dark blood and clot, estimated as 10 </a:t>
            </a:r>
            <a:r>
              <a:rPr lang="en-US" sz="2800" dirty="0"/>
              <a:t>mL.</a:t>
            </a:r>
            <a:endParaRPr lang="en-US" sz="2800" dirty="0"/>
          </a:p>
          <a:p>
            <a:pPr lvl="1" indent="-254884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Cervix </a:t>
            </a:r>
            <a:r>
              <a:rPr lang="en-US" sz="2800" dirty="0"/>
              <a:t>parous</a:t>
            </a:r>
            <a:r>
              <a:rPr lang="en-US" sz="2800" dirty="0"/>
              <a:t> with no CMT, cervical os open to fingertip.</a:t>
            </a:r>
          </a:p>
          <a:p>
            <a:pPr lvl="1" indent="-254884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Uterus </a:t>
            </a:r>
            <a:r>
              <a:rPr lang="en-US" sz="2800" dirty="0"/>
              <a:t>midposition</a:t>
            </a:r>
            <a:r>
              <a:rPr lang="en-US" sz="2800" dirty="0"/>
              <a:t>, 8 weeks size, </a:t>
            </a:r>
            <a:r>
              <a:rPr lang="en-US" sz="2800" dirty="0"/>
              <a:t>nontender</a:t>
            </a:r>
            <a:endParaRPr lang="en-US" sz="2800" dirty="0"/>
          </a:p>
          <a:p>
            <a:pPr lvl="1" indent="-254884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Adnexae</a:t>
            </a:r>
            <a:r>
              <a:rPr lang="en-US" sz="2800" dirty="0"/>
              <a:t> without masses or tenderness</a:t>
            </a:r>
          </a:p>
          <a:p>
            <a:pPr lvl="1" indent="-254884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Rectal exam notable for external hemorrhoids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5362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648010" algn="l"/>
                <a:tab pos="1304659" algn="l"/>
                <a:tab pos="1961309" algn="l"/>
                <a:tab pos="2617959" algn="l"/>
                <a:tab pos="3274608" algn="l"/>
                <a:tab pos="3931258" algn="l"/>
                <a:tab pos="4587908" algn="l"/>
                <a:tab pos="5244557" algn="l"/>
                <a:tab pos="5901207" algn="l"/>
                <a:tab pos="6557857" algn="l"/>
                <a:tab pos="7214506" algn="l"/>
                <a:tab pos="7871156" algn="l"/>
                <a:tab pos="8285882" algn="l"/>
                <a:tab pos="8700608" algn="l"/>
                <a:tab pos="9115335" algn="l"/>
                <a:tab pos="9530061" algn="l"/>
                <a:tab pos="9532941" algn="l"/>
                <a:tab pos="9535821" algn="l"/>
              </a:tabLst>
            </a:pPr>
            <a:r>
              <a:rPr lang="en-US" sz="2800" dirty="0"/>
              <a:t>Laboratory Tests	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6386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Laboratory Tests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CBC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Type and Rh</a:t>
            </a:r>
            <a:r>
              <a:rPr lang="en-US" sz="2800" dirty="0" smtClean="0"/>
              <a:t>/</a:t>
            </a:r>
            <a:r>
              <a:rPr lang="en-US" sz="2800" dirty="0" smtClean="0"/>
              <a:t>Crossmatch</a:t>
            </a:r>
            <a:endParaRPr lang="en-US" sz="2800" dirty="0"/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Electrolytes?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Renal or Liver Panel?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HCG?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Coagulation Studies?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Others?	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7410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362880" y="1457433"/>
            <a:ext cx="8228160" cy="5005966"/>
          </a:xfrm>
          <a:ln/>
        </p:spPr>
        <p:txBody>
          <a:bodyPr/>
          <a:lstStyle/>
          <a:p>
            <a:pPr marL="388806" indent="-292325">
              <a:buClrTx/>
              <a:buSzPct val="45000"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Laboratory Tests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CBC</a:t>
            </a:r>
          </a:p>
          <a:p>
            <a:pPr marL="1660344" lvl="2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WBC 7.4K, </a:t>
            </a:r>
            <a:r>
              <a:rPr lang="en-US" sz="2000" dirty="0"/>
              <a:t>Hct</a:t>
            </a:r>
            <a:r>
              <a:rPr lang="en-US" sz="2000" dirty="0"/>
              <a:t> 31%, </a:t>
            </a:r>
            <a:r>
              <a:rPr lang="en-US" sz="2000" dirty="0"/>
              <a:t>Hgb</a:t>
            </a:r>
            <a:r>
              <a:rPr lang="en-US" sz="2000" dirty="0"/>
              <a:t> 9.7%, </a:t>
            </a:r>
            <a:r>
              <a:rPr lang="en-US" sz="2000" dirty="0"/>
              <a:t>Plts</a:t>
            </a:r>
            <a:r>
              <a:rPr lang="en-US" sz="2000" dirty="0"/>
              <a:t> 197K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Type and Rh/ Type and </a:t>
            </a:r>
            <a:r>
              <a:rPr lang="en-US" sz="2000" dirty="0"/>
              <a:t>Crossmatch</a:t>
            </a:r>
            <a:endParaRPr lang="en-US" sz="2000" dirty="0"/>
          </a:p>
          <a:p>
            <a:pPr marL="1660344" lvl="2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O negative</a:t>
            </a:r>
          </a:p>
          <a:p>
            <a:pPr marL="1660344" lvl="2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No cross match ordered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Electrolytes</a:t>
            </a:r>
          </a:p>
          <a:p>
            <a:pPr marL="1660344" lvl="2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Not Ordered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Renal and Liver Panels</a:t>
            </a:r>
          </a:p>
          <a:p>
            <a:pPr marL="1660344" lvl="2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000" dirty="0"/>
              <a:t>Not ordered</a:t>
            </a:r>
          </a:p>
          <a:p>
            <a:pPr marL="388806" indent="-292325">
              <a:buClrTx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Rectangle 1"/>
          <p:cNvSpPr>
            <a:spLocks noGrp="1" noChangeArrowheads="1"/>
          </p:cNvSpPr>
          <p:nvPr>
            <p:ph type="title"/>
          </p:nvPr>
        </p:nvSpPr>
        <p:spPr>
          <a:xfrm>
            <a:off x="28345" y="-228600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8434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15025" y="838200"/>
            <a:ext cx="8228160" cy="5229189"/>
          </a:xfrm>
          <a:ln/>
        </p:spPr>
        <p:txBody>
          <a:bodyPr>
            <a:normAutofit fontScale="92500"/>
          </a:bodyPr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Laboratory Tests</a:t>
            </a:r>
          </a:p>
          <a:p>
            <a:pPr marL="829452" lvl="1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HCG</a:t>
            </a:r>
          </a:p>
          <a:p>
            <a:pPr marL="1660344" lvl="2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Urine pregnancy test positive</a:t>
            </a:r>
          </a:p>
          <a:p>
            <a:pPr marL="1660344" lvl="2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B-HCG 47,443</a:t>
            </a:r>
          </a:p>
          <a:p>
            <a:pPr marL="829452" lvl="1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Coagulation Studies</a:t>
            </a:r>
          </a:p>
          <a:p>
            <a:pPr marL="1660344" lvl="2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Not Ordered</a:t>
            </a:r>
          </a:p>
          <a:p>
            <a:pPr marL="829452" lvl="1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Other</a:t>
            </a:r>
          </a:p>
          <a:p>
            <a:pPr marL="1660344" lvl="2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Chlamydia and Gonorrhea	testing negative</a:t>
            </a:r>
          </a:p>
          <a:p>
            <a:pPr marL="1660344" lvl="2" indent="0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Wet prep for trichomonas, bacterial </a:t>
            </a:r>
            <a:r>
              <a:rPr lang="en-US" sz="2800" dirty="0"/>
              <a:t>vaginosis</a:t>
            </a:r>
            <a:r>
              <a:rPr lang="en-US" sz="2800" dirty="0"/>
              <a:t> and </a:t>
            </a:r>
            <a:r>
              <a:rPr lang="en-US" sz="2800" dirty="0"/>
              <a:t>candidal</a:t>
            </a:r>
            <a:r>
              <a:rPr lang="en-US" sz="2800" dirty="0"/>
              <a:t> infections negative</a:t>
            </a:r>
          </a:p>
          <a:p>
            <a:pPr marL="2073631" lvl="2" indent="-413287"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sz="2800" dirty="0"/>
          </a:p>
          <a:p>
            <a:pPr marL="387366" indent="-292325">
              <a:buClrTx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19458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390246" indent="-290884">
              <a:buClrTx/>
              <a:buSzPct val="4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Imaging Tests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20482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Imaging Tests 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Ultrasound is gold standard for pregnancy imaging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CT scan 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MRI 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Text Box 1"/>
          <p:cNvSpPr txBox="1">
            <a:spLocks noChangeArrowheads="1"/>
          </p:cNvSpPr>
          <p:nvPr/>
        </p:nvSpPr>
        <p:spPr bwMode="auto">
          <a:xfrm>
            <a:off x="456480" y="-21603"/>
            <a:ext cx="8225280" cy="1731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35268" rIns="0" bIns="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5pPr>
            <a:lvl6pPr marL="25146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6pPr>
            <a:lvl7pPr marL="29718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7pPr>
            <a:lvl8pPr marL="34290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8pPr>
            <a:lvl9pPr marL="38862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9pPr>
          </a:lstStyle>
          <a:p>
            <a:pPr algn="ctr">
              <a:buClrTx/>
              <a:buFontTx/>
              <a:buNone/>
            </a:pPr>
            <a:r>
              <a:rPr lang="en-US" sz="4000" dirty="0"/>
              <a:t>An Approach to Diagnosis and Management of  First Trimester Bleeding 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21506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Imaging Tests  </a:t>
            </a:r>
          </a:p>
          <a:p>
            <a:pPr marL="78193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 smtClean="0"/>
              <a:t>   Ultrasound </a:t>
            </a:r>
            <a:r>
              <a:rPr lang="en-US" sz="2800" dirty="0"/>
              <a:t>shows an intrauterine singleton pregnancy, consistent with </a:t>
            </a:r>
            <a:r>
              <a:rPr lang="en-US" sz="2800" dirty="0" smtClean="0"/>
              <a:t>8 </a:t>
            </a:r>
            <a:r>
              <a:rPr lang="en-US" sz="2800" dirty="0"/>
              <a:t>weeks 1 day, with no fetal cardiac activity. There is a small </a:t>
            </a:r>
            <a:r>
              <a:rPr lang="en-US" sz="2800" dirty="0"/>
              <a:t>subchorionic</a:t>
            </a:r>
            <a:r>
              <a:rPr lang="en-US" sz="2800" dirty="0"/>
              <a:t> bleed. The </a:t>
            </a:r>
            <a:r>
              <a:rPr lang="en-US" sz="2800" dirty="0"/>
              <a:t>adnexae</a:t>
            </a:r>
            <a:r>
              <a:rPr lang="en-US" sz="2800" dirty="0"/>
              <a:t> appear normal and there is no free fluid in the pelvis.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2530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390246" indent="-290884">
              <a:buClrTx/>
              <a:buSzPct val="4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What are treatment options?</a:t>
            </a:r>
          </a:p>
          <a:p>
            <a:pPr marL="390246" indent="-290884">
              <a:buClrTx/>
              <a:buSzPct val="4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3554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Expectant Management</a:t>
            </a:r>
          </a:p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Medical Management (Misoprostol, trade name </a:t>
            </a:r>
            <a:r>
              <a:rPr lang="en-US" sz="2800" dirty="0"/>
              <a:t>cytotec</a:t>
            </a:r>
            <a:r>
              <a:rPr lang="en-US" sz="2800" dirty="0"/>
              <a:t>)</a:t>
            </a:r>
          </a:p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Surgical Management (“D&amp;C” or D&amp;E”)</a:t>
            </a:r>
          </a:p>
          <a:p>
            <a:pPr marL="95041" indent="0">
              <a:buClrTx/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4578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5135579"/>
          </a:xfrm>
          <a:ln/>
        </p:spPr>
        <p:txBody>
          <a:bodyPr/>
          <a:lstStyle/>
          <a:p>
            <a:pPr marL="390246" indent="-290884">
              <a:buClrTx/>
              <a:buSzPct val="4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400" dirty="0"/>
              <a:t>Expectant Management</a:t>
            </a:r>
          </a:p>
          <a:p>
            <a:pPr marL="780492" lvl="1" indent="-289445">
              <a:buClrTx/>
              <a:buSzPct val="7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400" dirty="0"/>
              <a:t>Non-invasive</a:t>
            </a:r>
          </a:p>
          <a:p>
            <a:pPr marL="2073631" lvl="2" indent="-413287">
              <a:buFont typeface="Times New Roman" charset="0"/>
              <a:buChar char="•"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400" dirty="0" smtClean="0"/>
              <a:t>recommended </a:t>
            </a:r>
            <a:r>
              <a:rPr lang="en-US" sz="2400" dirty="0"/>
              <a:t>for patients who do not want any intervention.</a:t>
            </a:r>
          </a:p>
          <a:p>
            <a:pPr marL="780492" lvl="1" indent="-289445">
              <a:buClrTx/>
              <a:buSzPct val="7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400" dirty="0"/>
              <a:t>Unpredictable</a:t>
            </a:r>
          </a:p>
          <a:p>
            <a:pPr marL="2073631" lvl="2" indent="-413287">
              <a:buFont typeface="Times New Roman" charset="0"/>
              <a:buChar char="•"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400" dirty="0"/>
              <a:t>May take days to weeks to complete</a:t>
            </a:r>
          </a:p>
          <a:p>
            <a:pPr marL="2073631" lvl="2" indent="-413287">
              <a:buFont typeface="Times New Roman" charset="0"/>
              <a:buChar char="•"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400" dirty="0"/>
              <a:t>Bleeding and cramping may be prolonged</a:t>
            </a:r>
          </a:p>
          <a:p>
            <a:pPr marL="2073631" lvl="2" indent="-413287"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endParaRPr lang="en-US" sz="2400" dirty="0"/>
          </a:p>
          <a:p>
            <a:pPr marL="780492" lvl="1" indent="-289445">
              <a:buClrTx/>
              <a:buSzPct val="7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400" dirty="0"/>
              <a:t>Risk of subsequent need for surgery up to 20%</a:t>
            </a:r>
          </a:p>
          <a:p>
            <a:pPr marL="780492" lvl="1" indent="-289445">
              <a:buClrTx/>
              <a:buSzPct val="7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endParaRPr lang="en-US" sz="2400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1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5602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390246" indent="-290884">
              <a:buClrTx/>
              <a:buSzPct val="4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Medical Management</a:t>
            </a:r>
          </a:p>
          <a:p>
            <a:pPr marL="780492" lvl="1" indent="-289445">
              <a:buClrTx/>
              <a:buSzPct val="7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Relatively non-invasive</a:t>
            </a:r>
          </a:p>
          <a:p>
            <a:pPr marL="780492" lvl="1" indent="-289445">
              <a:buClrTx/>
              <a:buSzPct val="7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Usually effective within 24-48 hours</a:t>
            </a:r>
          </a:p>
          <a:p>
            <a:pPr marL="2073631" lvl="2" indent="-413287">
              <a:buFont typeface="Times New Roman" charset="0"/>
              <a:buChar char="•"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70-90%  within 48 hours </a:t>
            </a:r>
          </a:p>
          <a:p>
            <a:pPr marL="780492" lvl="1" indent="-289445">
              <a:buClrTx/>
              <a:buSzPct val="7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Risk for subsequent need for surgery </a:t>
            </a:r>
          </a:p>
          <a:p>
            <a:pPr marL="2073631" lvl="2" indent="-413287">
              <a:buFont typeface="Times New Roman" charset="0"/>
              <a:buChar char="•"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10-30%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6626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5304077"/>
          </a:xfrm>
          <a:ln/>
        </p:spPr>
        <p:txBody>
          <a:bodyPr/>
          <a:lstStyle/>
          <a:p>
            <a:pPr marL="390246" indent="-290884">
              <a:buClrTx/>
              <a:buSzPct val="45000"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800" dirty="0"/>
              <a:t>Medical Management: Misoprostol</a:t>
            </a: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200" dirty="0">
                <a:latin typeface="ArialMT" charset="0"/>
                <a:cs typeface="ArialMT" charset="0"/>
              </a:rPr>
              <a:t>World Health Organization </a:t>
            </a:r>
            <a:r>
              <a:rPr lang="en-US" sz="2200" dirty="0" smtClean="0">
                <a:latin typeface="ArialMT" charset="0"/>
                <a:cs typeface="ArialMT" charset="0"/>
              </a:rPr>
              <a:t>Recommendations </a:t>
            </a:r>
            <a:r>
              <a:rPr lang="en-US" sz="2200" dirty="0">
                <a:latin typeface="ArialMT" charset="0"/>
                <a:cs typeface="ArialMT" charset="0"/>
              </a:rPr>
              <a:t>2007   </a:t>
            </a:r>
            <a:endParaRPr lang="en-US" sz="2200" dirty="0" smtClean="0">
              <a:latin typeface="ArialMT" charset="0"/>
              <a:cs typeface="ArialMT" charset="0"/>
            </a:endParaRP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200" dirty="0" smtClean="0">
                <a:latin typeface="ArialMT" charset="0"/>
                <a:cs typeface="ArialMT" charset="0"/>
              </a:rPr>
              <a:t>Missed </a:t>
            </a:r>
            <a:r>
              <a:rPr lang="en-US" sz="2200" dirty="0">
                <a:latin typeface="ArialMT" charset="0"/>
                <a:cs typeface="ArialMT" charset="0"/>
              </a:rPr>
              <a:t>abortion: 800 mcg per vagina OR 600 mcg </a:t>
            </a:r>
            <a:r>
              <a:rPr lang="en-US" sz="2200" dirty="0" smtClean="0">
                <a:latin typeface="ArialMT" charset="0"/>
                <a:cs typeface="ArialMT" charset="0"/>
              </a:rPr>
              <a:t>sublingually (</a:t>
            </a:r>
            <a:r>
              <a:rPr lang="en-US" sz="2200" dirty="0">
                <a:latin typeface="ArialMT" charset="0"/>
                <a:cs typeface="ArialMT" charset="0"/>
              </a:rPr>
              <a:t>each of these is a single dose</a:t>
            </a:r>
            <a:r>
              <a:rPr lang="en-US" sz="2200" dirty="0" smtClean="0">
                <a:latin typeface="ArialMT" charset="0"/>
                <a:cs typeface="ArialMT" charset="0"/>
              </a:rPr>
              <a:t>)</a:t>
            </a: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200" dirty="0" smtClean="0">
                <a:latin typeface="ArialMT" charset="0"/>
                <a:cs typeface="ArialMT" charset="0"/>
              </a:rPr>
              <a:t>Incomplete </a:t>
            </a:r>
            <a:r>
              <a:rPr lang="en-US" sz="2200" dirty="0">
                <a:latin typeface="ArialMT" charset="0"/>
                <a:cs typeface="ArialMT" charset="0"/>
              </a:rPr>
              <a:t>abortion: 600 mcg orally (single dose)</a:t>
            </a: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200" dirty="0">
                <a:latin typeface="ArialMT" charset="0"/>
                <a:cs typeface="ArialMT" charset="0"/>
              </a:rPr>
              <a:t>Common Regimen: 400 mcg vaginally every four hours for four doses.</a:t>
            </a: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200" dirty="0">
                <a:latin typeface="ArialMT" charset="0"/>
                <a:cs typeface="ArialMT" charset="0"/>
              </a:rPr>
              <a:t>Increased effectiveness with vaginal </a:t>
            </a:r>
            <a:r>
              <a:rPr lang="en-US" sz="2200" dirty="0" smtClean="0">
                <a:latin typeface="ArialMT" charset="0"/>
                <a:cs typeface="ArialMT" charset="0"/>
              </a:rPr>
              <a:t>administration</a:t>
            </a:r>
            <a:endParaRPr lang="en-US" sz="2200" dirty="0">
              <a:latin typeface="ArialMT" charset="0"/>
              <a:cs typeface="ArialMT" charset="0"/>
            </a:endParaRP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200" dirty="0">
                <a:latin typeface="ArialMT" charset="0"/>
                <a:cs typeface="ArialMT" charset="0"/>
              </a:rPr>
              <a:t>Decreased side effects</a:t>
            </a: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r>
              <a:rPr lang="en-US" sz="2200" dirty="0">
                <a:latin typeface="ArialMT" charset="0"/>
                <a:cs typeface="ArialMT" charset="0"/>
              </a:rPr>
              <a:t>Lower risk of medical complications than with surgery.</a:t>
            </a:r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endParaRPr lang="en-US" sz="2200" dirty="0"/>
          </a:p>
          <a:p>
            <a:pPr marL="390246" indent="-290884">
              <a:buClrTx/>
              <a:buNone/>
              <a:tabLst>
                <a:tab pos="390246" algn="l"/>
                <a:tab pos="492487" algn="l"/>
                <a:tab pos="907213" algn="l"/>
                <a:tab pos="1321940" algn="l"/>
                <a:tab pos="1736666" algn="l"/>
                <a:tab pos="2151392" algn="l"/>
                <a:tab pos="2566118" algn="l"/>
                <a:tab pos="2980844" algn="l"/>
                <a:tab pos="3395570" algn="l"/>
                <a:tab pos="3810296" algn="l"/>
                <a:tab pos="4225022" algn="l"/>
                <a:tab pos="4639748" algn="l"/>
                <a:tab pos="5054475" algn="l"/>
                <a:tab pos="5469201" algn="l"/>
                <a:tab pos="5883927" algn="l"/>
                <a:tab pos="6298653" algn="l"/>
                <a:tab pos="6713379" algn="l"/>
                <a:tab pos="7128105" algn="l"/>
                <a:tab pos="7542831" algn="l"/>
                <a:tab pos="7957557" algn="l"/>
                <a:tab pos="8372284" algn="l"/>
              </a:tabLst>
            </a:pPr>
            <a:endParaRPr lang="en-US" sz="2200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7650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26396"/>
          </a:xfrm>
          <a:ln/>
        </p:spPr>
        <p:txBody>
          <a:bodyPr/>
          <a:lstStyle/>
          <a:p>
            <a:pPr marL="388806" indent="-292325">
              <a:buClrTx/>
              <a:buSzPct val="45000"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/>
              <a:t>Surgical Management</a:t>
            </a:r>
          </a:p>
          <a:p>
            <a:pPr marL="388806" indent="-292325">
              <a:buSzPct val="45000"/>
              <a:buFont typeface="Wingdings" charset="0"/>
              <a:buChar char=""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/>
              <a:t>Invasive</a:t>
            </a:r>
          </a:p>
          <a:p>
            <a:pPr marL="1344980" lvl="1" indent="-515528">
              <a:buFont typeface="Times New Roman" charset="0"/>
              <a:buChar char="–"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/>
              <a:t>Surgical risks of perforation, infection</a:t>
            </a:r>
          </a:p>
          <a:p>
            <a:pPr marL="388806" indent="-292325">
              <a:buSzPct val="45000"/>
              <a:buFont typeface="Wingdings" charset="0"/>
              <a:buChar char=""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/>
              <a:t>Quick</a:t>
            </a:r>
          </a:p>
          <a:p>
            <a:pPr marL="1344980" lvl="1" indent="-515528">
              <a:buFont typeface="Times New Roman" charset="0"/>
              <a:buChar char="–"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/>
              <a:t>Patient can control timing</a:t>
            </a:r>
          </a:p>
          <a:p>
            <a:pPr marL="388806" indent="-292325">
              <a:buSzPct val="45000"/>
              <a:buFont typeface="Wingdings" charset="0"/>
              <a:buChar char=""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/>
              <a:t>Effective</a:t>
            </a:r>
          </a:p>
          <a:p>
            <a:pPr marL="1344980" lvl="1" indent="-515528">
              <a:buFont typeface="Times New Roman" charset="0"/>
              <a:buChar char="–"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/>
              <a:t>5-10% failure rate</a:t>
            </a:r>
          </a:p>
          <a:p>
            <a:pPr marL="388806" indent="-292325">
              <a:buClrTx/>
              <a:buSzPct val="45000"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8674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8"/>
            <a:ext cx="8228160" cy="4690573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Expectant </a:t>
            </a:r>
            <a:r>
              <a:rPr lang="en-US" sz="2800" dirty="0" smtClean="0"/>
              <a:t>Management:</a:t>
            </a:r>
            <a:endParaRPr lang="en-US" sz="2800" dirty="0"/>
          </a:p>
          <a:p>
            <a:pPr marL="491047" lvl="1" indent="0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Patient must be </a:t>
            </a:r>
            <a:r>
              <a:rPr lang="en-US" sz="2800" dirty="0"/>
              <a:t>hemodynamically</a:t>
            </a:r>
            <a:r>
              <a:rPr lang="en-US" sz="2800" dirty="0"/>
              <a:t> stable</a:t>
            </a:r>
          </a:p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Medical </a:t>
            </a:r>
            <a:r>
              <a:rPr lang="en-US" sz="2800" dirty="0" smtClean="0"/>
              <a:t>Management:</a:t>
            </a:r>
            <a:endParaRPr lang="en-US" sz="2800" dirty="0"/>
          </a:p>
          <a:p>
            <a:pPr marL="491047" lvl="1" indent="0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Patient must be </a:t>
            </a:r>
            <a:r>
              <a:rPr lang="en-US" sz="2800" dirty="0"/>
              <a:t>hemodynamically</a:t>
            </a:r>
            <a:r>
              <a:rPr lang="en-US" sz="2800" dirty="0"/>
              <a:t> stable</a:t>
            </a:r>
          </a:p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Surgical </a:t>
            </a:r>
            <a:r>
              <a:rPr lang="en-US" sz="2800" dirty="0" smtClean="0"/>
              <a:t>Management:</a:t>
            </a:r>
            <a:endParaRPr lang="en-US" sz="2800" dirty="0"/>
          </a:p>
          <a:p>
            <a:pPr marL="491047" lvl="1" indent="0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Necessary if patient is not </a:t>
            </a:r>
            <a:r>
              <a:rPr lang="en-US" sz="2800" dirty="0"/>
              <a:t>hemodynamically</a:t>
            </a:r>
            <a:r>
              <a:rPr lang="en-US" sz="2800" dirty="0"/>
              <a:t> stable or if there is evidence of septic abortion</a:t>
            </a:r>
          </a:p>
          <a:p>
            <a:pPr marL="387366" indent="-292325">
              <a:buClrTx/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7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29698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0" y="1604328"/>
            <a:ext cx="8684641" cy="4690573"/>
          </a:xfrm>
          <a:ln/>
        </p:spPr>
        <p:txBody>
          <a:bodyPr/>
          <a:lstStyle/>
          <a:p>
            <a:pPr marL="388806" indent="-292325">
              <a:buClrTx/>
              <a:buSzPct val="45000"/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D.R. </a:t>
            </a:r>
            <a:r>
              <a:rPr lang="en-US" sz="2800" dirty="0" smtClean="0">
                <a:latin typeface="ArialMT" charset="0"/>
                <a:cs typeface="ArialMT" charset="0"/>
              </a:rPr>
              <a:t>decides </a:t>
            </a:r>
            <a:r>
              <a:rPr lang="en-US" sz="2800" dirty="0">
                <a:latin typeface="ArialMT" charset="0"/>
                <a:cs typeface="ArialMT" charset="0"/>
              </a:rPr>
              <a:t>to proceed with surgical management ( “D&amp;C”). 	</a:t>
            </a:r>
          </a:p>
          <a:p>
            <a:pPr marL="388806" indent="-292325">
              <a:buClrTx/>
              <a:buSzPct val="45000"/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endParaRPr lang="en-US" sz="2800" dirty="0">
              <a:latin typeface="ArialMT" charset="0"/>
              <a:cs typeface="ArialMT" charset="0"/>
            </a:endParaRPr>
          </a:p>
          <a:p>
            <a:pPr marL="388806" indent="-292325">
              <a:buSzPct val="45000"/>
              <a:buFont typeface="Wingdings" charset="0"/>
              <a:buChar char=""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What is your next step?</a:t>
            </a:r>
          </a:p>
          <a:p>
            <a:pPr marL="388806" indent="-292325">
              <a:buSzPct val="45000"/>
              <a:buFont typeface="Wingdings" charset="0"/>
              <a:buChar char=""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Any additional treatment?</a:t>
            </a:r>
          </a:p>
          <a:p>
            <a:pPr marL="388806" indent="-292325">
              <a:buSzPct val="45000"/>
              <a:buFont typeface="Wingdings" charset="0"/>
              <a:buChar char=""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Any follow up needed?</a:t>
            </a:r>
          </a:p>
          <a:p>
            <a:pPr marL="388806" indent="-292325">
              <a:buSzPct val="45000"/>
              <a:buFont typeface="Wingdings" charset="0"/>
              <a:buChar char=""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What postoperative instructions do you give?</a:t>
            </a:r>
          </a:p>
          <a:p>
            <a:pPr marL="388806" indent="-292325">
              <a:buClrTx/>
              <a:buSzPct val="45000"/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endParaRPr lang="en-US" sz="2800" dirty="0">
              <a:latin typeface="ArialMT" charset="0"/>
              <a:cs typeface="ArialMT" charset="0"/>
            </a:endParaRP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Rectangle 1"/>
          <p:cNvSpPr>
            <a:spLocks noGrp="1" noChangeArrowheads="1"/>
          </p:cNvSpPr>
          <p:nvPr>
            <p:ph type="title"/>
          </p:nvPr>
        </p:nvSpPr>
        <p:spPr>
          <a:xfrm>
            <a:off x="381000" y="-228600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30722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228600" y="1066800"/>
            <a:ext cx="8228160" cy="4690572"/>
          </a:xfrm>
          <a:ln/>
        </p:spPr>
        <p:txBody>
          <a:bodyPr/>
          <a:lstStyle/>
          <a:p>
            <a:pPr marL="96481" indent="0">
              <a:buClrTx/>
              <a:buSzPct val="45000"/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 smtClean="0">
                <a:latin typeface="ArialMT" charset="0"/>
                <a:cs typeface="ArialMT" charset="0"/>
              </a:rPr>
              <a:t>What </a:t>
            </a:r>
            <a:r>
              <a:rPr lang="en-US" sz="2800" dirty="0">
                <a:latin typeface="ArialMT" charset="0"/>
                <a:cs typeface="ArialMT" charset="0"/>
              </a:rPr>
              <a:t>is your next step?</a:t>
            </a:r>
          </a:p>
          <a:p>
            <a:pPr marL="829452" lvl="1" indent="0"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Obtain informed consent</a:t>
            </a:r>
          </a:p>
          <a:p>
            <a:pPr marL="829452" lvl="1" indent="0"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Be aware of any local laws regarding disposition of fetal remains</a:t>
            </a:r>
          </a:p>
          <a:p>
            <a:pPr marL="96481" indent="0">
              <a:buClrTx/>
              <a:buSzPct val="45000"/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Any additional </a:t>
            </a:r>
            <a:r>
              <a:rPr lang="en-US" sz="2800" dirty="0" smtClean="0">
                <a:latin typeface="ArialMT" charset="0"/>
                <a:cs typeface="ArialMT" charset="0"/>
              </a:rPr>
              <a:t>treatment?</a:t>
            </a:r>
            <a:endParaRPr lang="en-US" sz="2800" dirty="0">
              <a:latin typeface="ArialMT" charset="0"/>
              <a:cs typeface="ArialMT" charset="0"/>
            </a:endParaRPr>
          </a:p>
          <a:p>
            <a:pPr marL="829452" lvl="1" indent="0"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Rhogam</a:t>
            </a:r>
            <a:endParaRPr lang="en-US" sz="2800" dirty="0">
              <a:latin typeface="ArialMT" charset="0"/>
              <a:cs typeface="ArialMT" charset="0"/>
            </a:endParaRPr>
          </a:p>
          <a:p>
            <a:pPr marL="829452" lvl="1" indent="0"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Emotional support</a:t>
            </a:r>
          </a:p>
          <a:p>
            <a:pPr marL="829452" lvl="1" indent="0"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Antibiotics?</a:t>
            </a:r>
          </a:p>
          <a:p>
            <a:pPr marL="829452" lvl="1" indent="0"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Contraception plans</a:t>
            </a:r>
          </a:p>
          <a:p>
            <a:pPr marL="388806" indent="-292325">
              <a:buClrTx/>
              <a:buSzPct val="45000"/>
              <a:buNone/>
              <a:tabLst>
                <a:tab pos="38880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  <a:tab pos="8707809" algn="l"/>
                <a:tab pos="9122535" algn="l"/>
                <a:tab pos="9537261" algn="l"/>
              </a:tabLst>
            </a:pPr>
            <a:endParaRPr lang="en-US" sz="2200" dirty="0">
              <a:latin typeface="ArialMT" charset="0"/>
              <a:cs typeface="ArialMT" charset="0"/>
            </a:endParaRP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Rectangle 1"/>
          <p:cNvSpPr>
            <a:spLocks noGrp="1" noChangeArrowheads="1"/>
          </p:cNvSpPr>
          <p:nvPr>
            <p:ph type="title"/>
          </p:nvPr>
        </p:nvSpPr>
        <p:spPr>
          <a:xfrm>
            <a:off x="0" y="-572461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>
                <a:solidFill>
                  <a:srgbClr val="000090"/>
                </a:solidFill>
              </a:rPr>
              <a:t>Definitions</a:t>
            </a:r>
          </a:p>
        </p:txBody>
      </p:sp>
      <p:sp>
        <p:nvSpPr>
          <p:cNvPr id="4098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26641" y="685800"/>
            <a:ext cx="8228160" cy="5818211"/>
          </a:xfrm>
          <a:ln/>
        </p:spPr>
        <p:txBody>
          <a:bodyPr tIns="22532"/>
          <a:lstStyle/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500" dirty="0"/>
              <a:t>A</a:t>
            </a:r>
            <a:r>
              <a:rPr lang="en-US" sz="2200" dirty="0"/>
              <a:t>bortion: medical term for pregnancy loss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Usually used prior to fetal viability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Fetal Demise (IUFD)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Threatened Abortion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Induced Abortion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 smtClean="0"/>
              <a:t>Voluntary </a:t>
            </a:r>
            <a:r>
              <a:rPr lang="en-US" sz="2200" dirty="0"/>
              <a:t>(elective)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Therapeutic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Spontaneous Abortion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Complete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Incomplete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Inevitable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Missed</a:t>
            </a:r>
          </a:p>
          <a:p>
            <a:pPr marL="1344980" lvl="1" indent="-515528">
              <a:buFont typeface="Times New Roman" charset="0"/>
              <a:buChar char="–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200" dirty="0"/>
              <a:t>Septic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8160" cy="1144921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Treatment of Spontaneous Abortion</a:t>
            </a:r>
          </a:p>
        </p:txBody>
      </p:sp>
      <p:sp>
        <p:nvSpPr>
          <p:cNvPr id="31746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228600" y="1524000"/>
            <a:ext cx="8228160" cy="4690572"/>
          </a:xfrm>
          <a:ln/>
        </p:spPr>
        <p:txBody>
          <a:bodyPr/>
          <a:lstStyle/>
          <a:p>
            <a:pPr marL="96481" indent="0">
              <a:buClrTx/>
              <a:buSzPct val="45000"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Any follow up needed? 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Usually within 2 weeks</a:t>
            </a:r>
          </a:p>
          <a:p>
            <a:pPr marL="96481" indent="0">
              <a:buClrTx/>
              <a:buSzPct val="45000"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What postoperative instructions do you give?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Call for fever, heavy bleeding, severe pain, foul-smelling discharge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Nothing in vagina for 2 weeks</a:t>
            </a:r>
          </a:p>
          <a:p>
            <a:pPr marL="829452" lvl="1" indent="0"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r>
              <a:rPr lang="en-US" sz="2800" dirty="0">
                <a:latin typeface="ArialMT" charset="0"/>
                <a:cs typeface="ArialMT" charset="0"/>
              </a:rPr>
              <a:t>Timing and planning for future pregnancy</a:t>
            </a:r>
          </a:p>
          <a:p>
            <a:pPr marL="829452" lvl="1" indent="0">
              <a:buClrTx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endParaRPr lang="en-US" sz="2800" dirty="0">
              <a:latin typeface="ArialMT" charset="0"/>
              <a:cs typeface="ArialMT" charset="0"/>
            </a:endParaRPr>
          </a:p>
          <a:p>
            <a:pPr marL="388806" indent="-292325">
              <a:buClrTx/>
              <a:buSzPct val="45000"/>
              <a:buNone/>
              <a:tabLst>
                <a:tab pos="388806" algn="l"/>
                <a:tab pos="491048" algn="l"/>
                <a:tab pos="905774" algn="l"/>
                <a:tab pos="1320500" algn="l"/>
                <a:tab pos="1735226" algn="l"/>
                <a:tab pos="2149952" algn="l"/>
                <a:tab pos="2564678" algn="l"/>
                <a:tab pos="2979404" algn="l"/>
                <a:tab pos="3394131" algn="l"/>
                <a:tab pos="3808857" algn="l"/>
                <a:tab pos="4223583" algn="l"/>
                <a:tab pos="4638309" algn="l"/>
                <a:tab pos="5053035" algn="l"/>
                <a:tab pos="5467761" algn="l"/>
                <a:tab pos="5882487" algn="l"/>
                <a:tab pos="6297213" algn="l"/>
                <a:tab pos="6711939" algn="l"/>
                <a:tab pos="7126666" algn="l"/>
                <a:tab pos="7541392" algn="l"/>
                <a:tab pos="7956118" algn="l"/>
                <a:tab pos="8370844" algn="l"/>
              </a:tabLst>
            </a:pPr>
            <a:endParaRPr lang="en-US" sz="2200" dirty="0">
              <a:latin typeface="ArialMT" charset="0"/>
              <a:cs typeface="ArialMT" charset="0"/>
            </a:endParaRP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Text Box 1"/>
          <p:cNvSpPr txBox="1">
            <a:spLocks noChangeArrowheads="1"/>
          </p:cNvSpPr>
          <p:nvPr/>
        </p:nvSpPr>
        <p:spPr bwMode="auto">
          <a:xfrm>
            <a:off x="0" y="263549"/>
            <a:ext cx="8684641" cy="11665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lIns="0" tIns="35268" rIns="0" bIns="0" anchor="ctr"/>
          <a:lstStyle>
            <a:lvl1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1pPr>
            <a:lvl2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2pPr>
            <a:lvl3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3pPr>
            <a:lvl4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4pPr>
            <a:lvl5pPr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5pPr>
            <a:lvl6pPr marL="25146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6pPr>
            <a:lvl7pPr marL="29718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7pPr>
            <a:lvl8pPr marL="34290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8pPr>
            <a:lvl9pPr marL="3886200" indent="-2286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charset="0"/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  <a:tab pos="7315200" algn="l"/>
                <a:tab pos="7772400" algn="l"/>
                <a:tab pos="8229600" algn="l"/>
                <a:tab pos="8686800" algn="l"/>
                <a:tab pos="9144000" algn="l"/>
              </a:tabLst>
              <a:defRPr>
                <a:solidFill>
                  <a:srgbClr val="000000"/>
                </a:solidFill>
                <a:latin typeface="Arial" charset="0"/>
                <a:ea typeface="ＭＳ Ｐゴシック" charset="0"/>
                <a:cs typeface="Arial Unicode MS" charset="0"/>
              </a:defRPr>
            </a:lvl9pPr>
          </a:lstStyle>
          <a:p>
            <a:pPr algn="ctr">
              <a:buClrTx/>
              <a:buFontTx/>
              <a:buNone/>
            </a:pPr>
            <a:r>
              <a:rPr lang="en-US" sz="2800" b="1" kern="0" dirty="0">
                <a:solidFill>
                  <a:srgbClr val="1C0E52"/>
                </a:solidFill>
                <a:latin typeface="Albany AMT"/>
                <a:ea typeface="ＭＳ Ｐゴシック"/>
                <a:cs typeface="+mj-cs"/>
              </a:rPr>
              <a:t>Differential Diagnosis of First Trimester Bleeding</a:t>
            </a:r>
            <a:endParaRPr lang="en-US" sz="4000" dirty="0">
              <a:solidFill>
                <a:schemeClr val="tx2">
                  <a:lumMod val="90000"/>
                  <a:lumOff val="10000"/>
                </a:schemeClr>
              </a:solidFill>
            </a:endParaRP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Rectangle 1"/>
          <p:cNvSpPr>
            <a:spLocks noGrp="1" noChangeArrowheads="1"/>
          </p:cNvSpPr>
          <p:nvPr>
            <p:ph type="title"/>
          </p:nvPr>
        </p:nvSpPr>
        <p:spPr>
          <a:xfrm>
            <a:off x="1704" y="-457200"/>
            <a:ext cx="8532241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Differential Diagnosis of First Trimester Bleeding</a:t>
            </a:r>
          </a:p>
        </p:txBody>
      </p:sp>
      <p:sp>
        <p:nvSpPr>
          <p:cNvPr id="6146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18433" y="914400"/>
            <a:ext cx="8228160" cy="4526396"/>
          </a:xfrm>
          <a:ln/>
        </p:spPr>
        <p:txBody>
          <a:bodyPr/>
          <a:lstStyle/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Trauma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Infection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Neoplasia</a:t>
            </a:r>
            <a:endParaRPr lang="en-US" sz="2800" dirty="0"/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Pregnancy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Urinary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GI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Vulvar</a:t>
            </a:r>
          </a:p>
          <a:p>
            <a:pPr marL="387366" indent="-292325">
              <a:buSzPct val="45000"/>
              <a:buFont typeface="Wingdings" charset="0"/>
              <a:buChar char=""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800" dirty="0"/>
              <a:t>Iatrogenic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Rectangle 1"/>
          <p:cNvSpPr>
            <a:spLocks noGrp="1" noChangeArrowheads="1"/>
          </p:cNvSpPr>
          <p:nvPr>
            <p:ph type="title"/>
          </p:nvPr>
        </p:nvSpPr>
        <p:spPr>
          <a:xfrm>
            <a:off x="0" y="-381000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/>
              <a:t>Evaluation of First Trimester Vaginal Bleeding</a:t>
            </a:r>
          </a:p>
        </p:txBody>
      </p:sp>
      <p:sp>
        <p:nvSpPr>
          <p:cNvPr id="7170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8160" cy="4552318"/>
          </a:xfrm>
          <a:ln/>
        </p:spPr>
        <p:txBody>
          <a:bodyPr/>
          <a:lstStyle/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400" dirty="0" smtClean="0"/>
              <a:t>   D.R</a:t>
            </a:r>
            <a:r>
              <a:rPr lang="en-US" sz="2400" dirty="0"/>
              <a:t>. is a 34 </a:t>
            </a:r>
            <a:r>
              <a:rPr lang="en-US" sz="2400" dirty="0"/>
              <a:t>yo</a:t>
            </a:r>
            <a:r>
              <a:rPr lang="en-US" sz="2400" dirty="0"/>
              <a:t> G3P2 woman who presents to your office complaining of spotting since last night. Her LMP was 8 weeks ago and she had a positive pregnancy test </a:t>
            </a:r>
            <a:r>
              <a:rPr lang="en-US" sz="2400" dirty="0" smtClean="0"/>
              <a:t>10 days </a:t>
            </a:r>
            <a:r>
              <a:rPr lang="en-US" sz="2400" dirty="0"/>
              <a:t>ago. She is concerned as she does not remember any bleeding during her first two pregnancies. 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73629"/>
            <a:ext cx="8226720" cy="1143480"/>
          </a:xfrm>
          <a:ln/>
        </p:spPr>
        <p:txBody>
          <a:bodyPr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>
                <a:solidFill>
                  <a:srgbClr val="1C0E52"/>
                </a:solidFill>
              </a:rPr>
              <a:t>Evaluation of First Trimester Vaginal Bleeding</a:t>
            </a:r>
            <a:endParaRPr lang="en-US" dirty="0"/>
          </a:p>
        </p:txBody>
      </p:sp>
      <p:sp>
        <p:nvSpPr>
          <p:cNvPr id="8194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456481" y="1604329"/>
            <a:ext cx="8226720" cy="4524955"/>
          </a:xfrm>
          <a:ln/>
        </p:spPr>
        <p:txBody>
          <a:bodyPr/>
          <a:lstStyle/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800" dirty="0"/>
              <a:t>History</a:t>
            </a:r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endParaRPr lang="en-US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7" name="Rectangle 1"/>
          <p:cNvSpPr>
            <a:spLocks noGrp="1" noChangeArrowheads="1"/>
          </p:cNvSpPr>
          <p:nvPr>
            <p:ph type="title"/>
          </p:nvPr>
        </p:nvSpPr>
        <p:spPr>
          <a:xfrm>
            <a:off x="456481" y="263549"/>
            <a:ext cx="8228160" cy="1166522"/>
          </a:xfrm>
          <a:ln/>
        </p:spPr>
        <p:txBody>
          <a:bodyPr tIns="35268"/>
          <a:lstStyle/>
          <a:p>
            <a:pPr>
              <a:tabLst>
                <a:tab pos="0" algn="l"/>
                <a:tab pos="414726" algn="l"/>
                <a:tab pos="829452" algn="l"/>
                <a:tab pos="1244178" algn="l"/>
                <a:tab pos="1658904" algn="l"/>
                <a:tab pos="2073631" algn="l"/>
                <a:tab pos="2488357" algn="l"/>
                <a:tab pos="2903083" algn="l"/>
                <a:tab pos="3317809" algn="l"/>
                <a:tab pos="3732535" algn="l"/>
                <a:tab pos="4147261" algn="l"/>
                <a:tab pos="4561987" algn="l"/>
                <a:tab pos="4976713" algn="l"/>
                <a:tab pos="5391440" algn="l"/>
                <a:tab pos="5806166" algn="l"/>
                <a:tab pos="6220892" algn="l"/>
                <a:tab pos="6635618" algn="l"/>
                <a:tab pos="7050344" algn="l"/>
                <a:tab pos="7465070" algn="l"/>
                <a:tab pos="7879796" algn="l"/>
                <a:tab pos="8294522" algn="l"/>
              </a:tabLst>
            </a:pPr>
            <a:r>
              <a:rPr lang="en-US" sz="2800" dirty="0">
                <a:solidFill>
                  <a:srgbClr val="1C0E52"/>
                </a:solidFill>
              </a:rPr>
              <a:t>Evaluation of First Trimester Vaginal Bleeding</a:t>
            </a:r>
            <a:endParaRPr lang="en-US" dirty="0"/>
          </a:p>
        </p:txBody>
      </p:sp>
      <p:sp>
        <p:nvSpPr>
          <p:cNvPr id="9218" name="Rectangle 2"/>
          <p:cNvSpPr>
            <a:spLocks noGrp="1" noChangeArrowheads="1"/>
          </p:cNvSpPr>
          <p:nvPr>
            <p:ph type="body" idx="1"/>
          </p:nvPr>
        </p:nvSpPr>
        <p:spPr>
          <a:xfrm>
            <a:off x="0" y="1604329"/>
            <a:ext cx="8684641" cy="4756820"/>
          </a:xfrm>
          <a:ln/>
        </p:spPr>
        <p:txBody>
          <a:bodyPr/>
          <a:lstStyle/>
          <a:p>
            <a:pPr marL="95041" indent="0">
              <a:buSzPct val="4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History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Basic gynecologic history: LMP, prior pregnancy, sexual activity, contraception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Medical history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Surgical history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Social history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Medications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Allergies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Family History</a:t>
            </a:r>
          </a:p>
          <a:p>
            <a:pPr marL="780492" lvl="1" indent="-289445">
              <a:buClrTx/>
              <a:buSzPct val="75000"/>
              <a:buNone/>
              <a:tabLst>
                <a:tab pos="387366" algn="l"/>
                <a:tab pos="489607" algn="l"/>
                <a:tab pos="904333" algn="l"/>
                <a:tab pos="1319059" algn="l"/>
                <a:tab pos="1733786" algn="l"/>
                <a:tab pos="2148512" algn="l"/>
                <a:tab pos="2563238" algn="l"/>
                <a:tab pos="2977964" algn="l"/>
                <a:tab pos="3392690" algn="l"/>
                <a:tab pos="3807416" algn="l"/>
                <a:tab pos="4222142" algn="l"/>
                <a:tab pos="4636868" algn="l"/>
                <a:tab pos="5051595" algn="l"/>
                <a:tab pos="5466321" algn="l"/>
                <a:tab pos="5881047" algn="l"/>
                <a:tab pos="6295773" algn="l"/>
                <a:tab pos="6710499" algn="l"/>
                <a:tab pos="7125225" algn="l"/>
                <a:tab pos="7539951" algn="l"/>
                <a:tab pos="7954677" algn="l"/>
                <a:tab pos="8369404" algn="l"/>
              </a:tabLst>
            </a:pPr>
            <a:r>
              <a:rPr lang="en-US" sz="2400" dirty="0"/>
              <a:t>Review of Systems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body" idx="4294967295"/>
          </p:nvPr>
        </p:nvSpPr>
        <p:spPr>
          <a:xfrm>
            <a:off x="228600" y="304800"/>
            <a:ext cx="8228013" cy="5284787"/>
          </a:xfrm>
          <a:ln/>
        </p:spPr>
        <p:txBody>
          <a:bodyPr>
            <a:normAutofit fontScale="92500" lnSpcReduction="20000"/>
          </a:bodyPr>
          <a:lstStyle/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 smtClean="0"/>
              <a:t>    D.R</a:t>
            </a:r>
            <a:r>
              <a:rPr lang="en-US" sz="2000" dirty="0"/>
              <a:t>. Is a 34 yo G3P2 </a:t>
            </a:r>
            <a:r>
              <a:rPr lang="en-US" sz="2000" dirty="0" smtClean="0"/>
              <a:t>AB </a:t>
            </a:r>
            <a:r>
              <a:rPr lang="en-US" sz="2000" dirty="0"/>
              <a:t>1 woman who presents to your office complaining of spotting since last night. Her LMP was 8 weeks ago and she had a positive pregnancy test 2 weeks ago. She is concerned as she does not remember any bleeding during her first two pregnancies. </a:t>
            </a:r>
            <a:endParaRPr lang="en-US" sz="2000" dirty="0" smtClean="0"/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endParaRPr lang="en-US" sz="2000" dirty="0"/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/>
              <a:t>GYN History: abnormal pap with CIN 2-3 on LEEP 4 years </a:t>
            </a:r>
            <a:r>
              <a:rPr lang="en-US" sz="2000" dirty="0" smtClean="0"/>
              <a:t>ago, no </a:t>
            </a:r>
            <a:r>
              <a:rPr lang="en-US" sz="2000" dirty="0"/>
              <a:t>STI, not currently using contraception. Menstrual history: 12yr/q 28-35days/5-7 days, heavy flow.</a:t>
            </a:r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/>
              <a:t>OB History: 2 uncomplicated vaginal deliveries at term, both over 4000gm</a:t>
            </a:r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 smtClean="0"/>
              <a:t>   Medical </a:t>
            </a:r>
            <a:r>
              <a:rPr lang="en-US" sz="2000" dirty="0"/>
              <a:t>History: depression with suicide attempt at 19; breast </a:t>
            </a:r>
            <a:r>
              <a:rPr lang="en-US" sz="2000" dirty="0"/>
              <a:t>fibroadenoma</a:t>
            </a:r>
            <a:endParaRPr lang="en-US" sz="2000" dirty="0"/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/>
              <a:t>Surgical History: D&amp;C for elective </a:t>
            </a:r>
            <a:r>
              <a:rPr lang="en-US" sz="2000" dirty="0"/>
              <a:t>Ab</a:t>
            </a:r>
            <a:r>
              <a:rPr lang="en-US" sz="2000" dirty="0"/>
              <a:t> at age 18; LEEP age 30.</a:t>
            </a:r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/>
              <a:t>Medications: Paxil</a:t>
            </a:r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/>
              <a:t>Family History: Sister with endometriosis</a:t>
            </a:r>
            <a:r>
              <a:rPr lang="en-US" sz="2000" dirty="0" smtClean="0"/>
              <a:t>. Mother </a:t>
            </a:r>
            <a:r>
              <a:rPr lang="en-US" sz="2000" dirty="0"/>
              <a:t>and MGM with breast cancer age 40, 66. MGF multiple sclerosis. PGF with prostate cancer age 85. </a:t>
            </a:r>
          </a:p>
          <a:p>
            <a:pPr indent="-306725">
              <a:buClrTx/>
              <a:buNone/>
              <a:tabLst>
                <a:tab pos="311045" algn="l"/>
                <a:tab pos="413287" algn="l"/>
                <a:tab pos="828013" algn="l"/>
                <a:tab pos="1242739" algn="l"/>
                <a:tab pos="1657465" algn="l"/>
                <a:tab pos="2072191" algn="l"/>
                <a:tab pos="2486917" algn="l"/>
                <a:tab pos="2901643" algn="l"/>
                <a:tab pos="3316369" algn="l"/>
                <a:tab pos="3731096" algn="l"/>
                <a:tab pos="4145822" algn="l"/>
                <a:tab pos="4560548" algn="l"/>
                <a:tab pos="4975274" algn="l"/>
                <a:tab pos="5390000" algn="l"/>
                <a:tab pos="5804726" algn="l"/>
                <a:tab pos="6219452" algn="l"/>
                <a:tab pos="6634178" algn="l"/>
                <a:tab pos="7048904" algn="l"/>
                <a:tab pos="7463631" algn="l"/>
                <a:tab pos="7878357" algn="l"/>
                <a:tab pos="8293083" algn="l"/>
              </a:tabLst>
            </a:pPr>
            <a:r>
              <a:rPr lang="en-US" sz="2000" dirty="0"/>
              <a:t>Social History: works as L&amp;D nurse, lives with husband and 2 children. Drinks 4-7 drinks per week. Smokes ½ pack cigarettes per day. No other substance use. History of domestic violence with assault by husband last year.</a:t>
            </a:r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BIDMC_Template_Slides">
  <a:themeElements>
    <a:clrScheme name="CVI_PPT_Template_Title_1 15">
      <a:dk1>
        <a:srgbClr val="131313"/>
      </a:dk1>
      <a:lt1>
        <a:srgbClr val="FFFFFF"/>
      </a:lt1>
      <a:dk2>
        <a:srgbClr val="1C0E52"/>
      </a:dk2>
      <a:lt2>
        <a:srgbClr val="808080"/>
      </a:lt2>
      <a:accent1>
        <a:srgbClr val="5C7F92"/>
      </a:accent1>
      <a:accent2>
        <a:srgbClr val="EFBD47"/>
      </a:accent2>
      <a:accent3>
        <a:srgbClr val="FFFFFF"/>
      </a:accent3>
      <a:accent4>
        <a:srgbClr val="0E0E0E"/>
      </a:accent4>
      <a:accent5>
        <a:srgbClr val="B5C0C7"/>
      </a:accent5>
      <a:accent6>
        <a:srgbClr val="D9AB3F"/>
      </a:accent6>
      <a:hlink>
        <a:srgbClr val="A3A86B"/>
      </a:hlink>
      <a:folHlink>
        <a:srgbClr val="5B1F69"/>
      </a:folHlink>
    </a:clrScheme>
    <a:fontScheme name="CVI_PPT_Template_Title_1">
      <a:majorFont>
        <a:latin typeface="Albany AMT"/>
        <a:ea typeface="ＭＳ Ｐゴシック"/>
        <a:cs typeface=""/>
      </a:majorFont>
      <a:minorFont>
        <a:latin typeface="Albany AMT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CVI_PPT_Template_Title_1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CVI_PPT_Template_Title_1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CVI_PPT_Template_Title_1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CVI_PPT_Template_Title_1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CVI_PPT_Template_Title_1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CVI_PPT_Template_Title_1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CVI_PPT_Template_Title_1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CVI_PPT_Template_Title_1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CVI_PPT_Template_Title_1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CVI_PPT_Template_Title_1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CVI_PPT_Template_Title_1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CVI_PPT_Template_Title_1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CVI_PPT_Template_Title_1 13">
        <a:dk1>
          <a:srgbClr val="131313"/>
        </a:dk1>
        <a:lt1>
          <a:srgbClr val="FFFFFF"/>
        </a:lt1>
        <a:dk2>
          <a:srgbClr val="2A6EBB"/>
        </a:dk2>
        <a:lt2>
          <a:srgbClr val="808080"/>
        </a:lt2>
        <a:accent1>
          <a:srgbClr val="2A6EBB"/>
        </a:accent1>
        <a:accent2>
          <a:srgbClr val="1C0E52"/>
        </a:accent2>
        <a:accent3>
          <a:srgbClr val="FFFFFF"/>
        </a:accent3>
        <a:accent4>
          <a:srgbClr val="0E0E0E"/>
        </a:accent4>
        <a:accent5>
          <a:srgbClr val="ACBADA"/>
        </a:accent5>
        <a:accent6>
          <a:srgbClr val="180C4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CVI_PPT_Template_Title_1 14">
        <a:dk1>
          <a:srgbClr val="131313"/>
        </a:dk1>
        <a:lt1>
          <a:srgbClr val="FFFFFF"/>
        </a:lt1>
        <a:dk2>
          <a:srgbClr val="2A6EBB"/>
        </a:dk2>
        <a:lt2>
          <a:srgbClr val="808080"/>
        </a:lt2>
        <a:accent1>
          <a:srgbClr val="2A6EBB"/>
        </a:accent1>
        <a:accent2>
          <a:srgbClr val="2A145D"/>
        </a:accent2>
        <a:accent3>
          <a:srgbClr val="FFFFFF"/>
        </a:accent3>
        <a:accent4>
          <a:srgbClr val="0E0E0E"/>
        </a:accent4>
        <a:accent5>
          <a:srgbClr val="ACBADA"/>
        </a:accent5>
        <a:accent6>
          <a:srgbClr val="251153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CVI_PPT_Template_Title_1 15">
        <a:dk1>
          <a:srgbClr val="131313"/>
        </a:dk1>
        <a:lt1>
          <a:srgbClr val="FFFFFF"/>
        </a:lt1>
        <a:dk2>
          <a:srgbClr val="1C0E52"/>
        </a:dk2>
        <a:lt2>
          <a:srgbClr val="808080"/>
        </a:lt2>
        <a:accent1>
          <a:srgbClr val="5C7F92"/>
        </a:accent1>
        <a:accent2>
          <a:srgbClr val="EFBD47"/>
        </a:accent2>
        <a:accent3>
          <a:srgbClr val="FFFFFF"/>
        </a:accent3>
        <a:accent4>
          <a:srgbClr val="0E0E0E"/>
        </a:accent4>
        <a:accent5>
          <a:srgbClr val="B5C0C7"/>
        </a:accent5>
        <a:accent6>
          <a:srgbClr val="D9AB3F"/>
        </a:accent6>
        <a:hlink>
          <a:srgbClr val="A3A86B"/>
        </a:hlink>
        <a:folHlink>
          <a:srgbClr val="5B1F69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IDMC_Template_Slides.potx</Template>
  <TotalTime>3784</TotalTime>
  <Words>2087</Words>
  <Application>Microsoft Macintosh PowerPoint</Application>
  <PresentationFormat>On-screen Show (4:3)</PresentationFormat>
  <Paragraphs>286</Paragraphs>
  <Slides>30</Slides>
  <Notes>3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1" baseType="lpstr">
      <vt:lpstr>BIDMC_Template_Slides</vt:lpstr>
      <vt:lpstr>An Approach to Diagnosis and Management of  First Trimester Bleeding  </vt:lpstr>
      <vt:lpstr>PowerPoint Presentation</vt:lpstr>
      <vt:lpstr>Definitions</vt:lpstr>
      <vt:lpstr>PowerPoint Presentation</vt:lpstr>
      <vt:lpstr>Differential Diagnosis of First Trimester Bleeding</vt:lpstr>
      <vt:lpstr>Evaluation of First Trimester Vaginal Bleeding</vt:lpstr>
      <vt:lpstr>Evaluation of First Trimester Vaginal Bleeding</vt:lpstr>
      <vt:lpstr>Evaluation of First Trimester Vaginal Bleeding</vt:lpstr>
      <vt:lpstr>PowerPoint Presentation</vt:lpstr>
      <vt:lpstr>Evaluation of First Trimester Vaginal Bleeding</vt:lpstr>
      <vt:lpstr>Evaluation of First Trimester Vaginal Bleeding</vt:lpstr>
      <vt:lpstr>PowerPoint Presentation</vt:lpstr>
      <vt:lpstr>Evaluation of First Trimester Vaginal Bleeding</vt:lpstr>
      <vt:lpstr>Evaluation of First Trimester Vaginal Bleeding</vt:lpstr>
      <vt:lpstr>Evaluation of First Trimester Vaginal Bleeding</vt:lpstr>
      <vt:lpstr>Evaluation of First Trimester Vaginal Bleeding</vt:lpstr>
      <vt:lpstr>Evaluation of First Trimester Vaginal Bleeding</vt:lpstr>
      <vt:lpstr>Evaluation of First Trimester Vaginal Bleeding</vt:lpstr>
      <vt:lpstr>Evaluation of First Trimester Vaginal Bleeding</vt:lpstr>
      <vt:lpstr>Evaluation of First Trimester Vaginal Bleeding</vt:lpstr>
      <vt:lpstr>Treatment of Spontaneous Abortion</vt:lpstr>
      <vt:lpstr>Treatment of Spontaneous Abortion</vt:lpstr>
      <vt:lpstr>Treatment of Spontaneous Abortion</vt:lpstr>
      <vt:lpstr>Treatment of Spontaneous Abortion</vt:lpstr>
      <vt:lpstr>Treatment of Spontaneous Abortion</vt:lpstr>
      <vt:lpstr>Treatment of Spontaneous Abortion</vt:lpstr>
      <vt:lpstr>Treatment of Spontaneous Abortion</vt:lpstr>
      <vt:lpstr>Treatment of Spontaneous Abortion</vt:lpstr>
      <vt:lpstr>Treatment of Spontaneous Abortion</vt:lpstr>
      <vt:lpstr>Treatment of Spontaneous Abortion</vt:lpstr>
    </vt:vector>
  </TitlesOfParts>
  <Company>Organiza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earch Day June 21, 2009</dc:title>
  <dc:creator>ledodge</dc:creator>
  <cp:lastModifiedBy>Celeste Royce</cp:lastModifiedBy>
  <cp:revision>25</cp:revision>
  <dcterms:created xsi:type="dcterms:W3CDTF">2008-12-09T17:22:32Z</dcterms:created>
  <dcterms:modified xsi:type="dcterms:W3CDTF">2016-02-22T14:32:30Z</dcterms:modified>
</cp:coreProperties>
</file>